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7099300" cy="102346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70" autoAdjust="0"/>
    <p:restoredTop sz="94660"/>
  </p:normalViewPr>
  <p:slideViewPr>
    <p:cSldViewPr>
      <p:cViewPr varScale="1">
        <p:scale>
          <a:sx n="54" d="100"/>
          <a:sy n="54" d="100"/>
        </p:scale>
        <p:origin x="700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1515F2D0-A787-4FFF-9D3A-590E109A058B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80CD9840-9F48-4F27-9D5C-DAF4E6DD02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1467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CD9840-9F48-4F27-9D5C-DAF4E6DD023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6187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75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688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9779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7879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5252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6391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14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5185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131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211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3509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24790D-67B5-45AD-A6B7-A18B056C62C5}" type="datetimeFigureOut">
              <a:rPr lang="ko-KR" altLang="en-US" smtClean="0"/>
              <a:t>2021-05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9406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3"/>
          <a:srcRect l="7909" t="9301" b="39384"/>
          <a:stretch/>
        </p:blipFill>
        <p:spPr>
          <a:xfrm>
            <a:off x="726245" y="4017469"/>
            <a:ext cx="1700241" cy="131689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73037" y="5443114"/>
            <a:ext cx="1300230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Calibri" panose="020F0502020204030204" pitchFamily="34" charset="0"/>
              </a:rPr>
              <a:t>Incubation time after thymol treatment (h)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296578" y="5249053"/>
            <a:ext cx="38822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03324" y="5249053"/>
            <a:ext cx="41048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073049" y="5249053"/>
            <a:ext cx="419847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72911" y="5249053"/>
            <a:ext cx="33993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956033" y="5462538"/>
            <a:ext cx="135342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-9559" y="4457354"/>
            <a:ext cx="13755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Fold difference of </a:t>
            </a:r>
            <a:r>
              <a:rPr lang="en-US" altLang="ko-KR" sz="800" i="1" dirty="0" smtClean="0">
                <a:latin typeface="Calibri" panose="020F0502020204030204" pitchFamily="34" charset="0"/>
              </a:rPr>
              <a:t>ERV29</a:t>
            </a:r>
            <a:endParaRPr lang="ko-KR" altLang="en-US" sz="800" i="1" dirty="0">
              <a:latin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1840161" y="4463649"/>
            <a:ext cx="13755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Fold </a:t>
            </a:r>
            <a:r>
              <a:rPr lang="en-US" altLang="ko-KR" sz="800" dirty="0">
                <a:latin typeface="Calibri" panose="020F0502020204030204" pitchFamily="34" charset="0"/>
              </a:rPr>
              <a:t>difference </a:t>
            </a:r>
            <a:r>
              <a:rPr lang="en-US" altLang="ko-KR" sz="800" dirty="0" smtClean="0">
                <a:latin typeface="Calibri" panose="020F0502020204030204" pitchFamily="34" charset="0"/>
              </a:rPr>
              <a:t>of </a:t>
            </a:r>
            <a:r>
              <a:rPr lang="en-US" altLang="ko-KR" sz="800" i="1" dirty="0" smtClean="0">
                <a:latin typeface="Calibri" panose="020F0502020204030204" pitchFamily="34" charset="0"/>
              </a:rPr>
              <a:t>KAR2</a:t>
            </a:r>
            <a:endParaRPr lang="ko-KR" altLang="en-US" sz="800" i="1" dirty="0">
              <a:latin typeface="Calibri" panose="020F050202020403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3704776" y="4464442"/>
            <a:ext cx="13755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Fold </a:t>
            </a:r>
            <a:r>
              <a:rPr lang="en-US" altLang="ko-KR" sz="800" dirty="0">
                <a:latin typeface="Calibri" panose="020F0502020204030204" pitchFamily="34" charset="0"/>
              </a:rPr>
              <a:t>difference </a:t>
            </a:r>
            <a:r>
              <a:rPr lang="en-US" altLang="ko-KR" sz="800" dirty="0" smtClean="0">
                <a:latin typeface="Calibri" panose="020F0502020204030204" pitchFamily="34" charset="0"/>
              </a:rPr>
              <a:t>of </a:t>
            </a:r>
            <a:r>
              <a:rPr lang="en-US" altLang="ko-KR" sz="800" i="1" dirty="0" smtClean="0">
                <a:latin typeface="Calibri" panose="020F0502020204030204" pitchFamily="34" charset="0"/>
              </a:rPr>
              <a:t>DER1</a:t>
            </a:r>
            <a:endParaRPr lang="ko-KR" altLang="en-US" sz="800" i="1" dirty="0">
              <a:latin typeface="Calibri" panose="020F050202020403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4"/>
          <a:srcRect l="7909" t="9302" b="41153"/>
          <a:stretch/>
        </p:blipFill>
        <p:spPr>
          <a:xfrm>
            <a:off x="4448133" y="4059867"/>
            <a:ext cx="1717171" cy="1217523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30998" y="5842154"/>
            <a:ext cx="6494345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ko-KR" sz="1100" b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Expression levels of the UPR downstream genes.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(A) Original image of RT-PCR for </a:t>
            </a:r>
            <a:r>
              <a:rPr lang="en-US" altLang="ko-KR" sz="1100" i="1" kern="0" dirty="0">
                <a:latin typeface="Calibri" panose="020F0502020204030204" pitchFamily="34" charset="0"/>
                <a:cs typeface="Times New Roman" panose="02020603050405020304" pitchFamily="18" charset="0"/>
              </a:rPr>
              <a:t>HXL1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 splicing and </a:t>
            </a:r>
            <a:r>
              <a:rPr lang="en-US" altLang="ko-KR" sz="1100" i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ACT1.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(B) The expression levels of </a:t>
            </a:r>
            <a:r>
              <a:rPr lang="en-GB" altLang="ko-KR" sz="1100" i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ERV29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altLang="ko-KR" sz="1100" i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KAR2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altLang="ko-KR" sz="1100" i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GB" altLang="ko-KR" sz="1100" i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DER1 </a:t>
            </a:r>
            <a:r>
              <a:rPr lang="en-GB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were measured in WT exposure to thymol (1 mM) through qRT-PCR analysis.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The cDNA was synthesized from total RNA in cells treated or not treated with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thymol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1 mM) for the indicated time points (0, 0.5, 1 and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h).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Duplicate technical experiments with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three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biological samples were performed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Calibri" panose="020F0502020204030204" pitchFamily="34" charset="0"/>
                <a:cs typeface="Calibri" panose="020F0502020204030204" pitchFamily="34" charset="0"/>
              </a:rPr>
              <a:t>The fold difference of target genes were statistically analyzed using the Bonferroni’s multiple comparison test performed with Prism software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altLang="ko-KR" sz="1100" dirty="0" smtClean="0">
                <a:latin typeface="Calibri" panose="020F0502020204030204" pitchFamily="34" charset="0"/>
                <a:cs typeface="Calibri" panose="020F0502020204030204" pitchFamily="34" charset="0"/>
              </a:rPr>
              <a:t>NS, not significant).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Error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bars indicate standard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error of means (S. E. M).</a:t>
            </a:r>
            <a:r>
              <a:rPr lang="en-US" altLang="ko-KR" sz="1100" i="1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Glycosylation levels of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Cpy1-FLAG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was monitored with anti-FLAG 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antibody under thymol treatment (Final concentration: 1 mM).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Tunicamycin (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TM, final concentration: 0.3 </a:t>
            </a:r>
            <a:r>
              <a:rPr lang="el-GR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μ</a:t>
            </a:r>
            <a:r>
              <a:rPr lang="en-US" altLang="ko-KR" sz="1100" kern="0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g/ml) </a:t>
            </a:r>
            <a:r>
              <a:rPr lang="en-US" altLang="ko-KR" sz="1100" kern="0" dirty="0">
                <a:latin typeface="Calibri" panose="020F0502020204030204" pitchFamily="34" charset="0"/>
                <a:cs typeface="Times New Roman" panose="02020603050405020304" pitchFamily="18" charset="0"/>
              </a:rPr>
              <a:t>is used as an inhibitor of protein glycosylation. The anti-Hog1 polyclonal antibody was used for loading control.</a:t>
            </a:r>
            <a:endParaRPr lang="ko-KR" altLang="en-US" sz="1100" dirty="0">
              <a:latin typeface="Calibri" panose="020F0502020204030204" pitchFamily="34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0439" y="3840174"/>
            <a:ext cx="397788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Calibri" panose="020F0502020204030204" pitchFamily="34" charset="0"/>
              </a:rPr>
              <a:t>B</a:t>
            </a:r>
            <a:endParaRPr lang="ko-KR" altLang="en-US" sz="1600" b="1" dirty="0">
              <a:latin typeface="Calibri" panose="020F050202020403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367892" y="2481366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Calibri" panose="020F0502020204030204" pitchFamily="34" charset="0"/>
              </a:rPr>
              <a:t>h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212976" y="2025626"/>
            <a:ext cx="2426938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CPY-FLAG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894481" y="2253261"/>
            <a:ext cx="1040745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KW75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40" name="직선 연결선 39"/>
          <p:cNvCxnSpPr/>
          <p:nvPr/>
        </p:nvCxnSpPr>
        <p:spPr>
          <a:xfrm>
            <a:off x="2839910" y="2466773"/>
            <a:ext cx="104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2753297" y="2481983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028550" y="2481983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290195" y="2481983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4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2828133" y="2244034"/>
            <a:ext cx="320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3528923" y="2486216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TM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900423" y="2253261"/>
            <a:ext cx="1040745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KW754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47" name="직선 연결선 46"/>
          <p:cNvCxnSpPr/>
          <p:nvPr/>
        </p:nvCxnSpPr>
        <p:spPr>
          <a:xfrm>
            <a:off x="3895497" y="2466773"/>
            <a:ext cx="104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3835159" y="2481983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086217" y="2481983"/>
            <a:ext cx="43152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340332" y="2481983"/>
            <a:ext cx="40005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4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536888" y="2481983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TM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005149" y="2253261"/>
            <a:ext cx="1040745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KW75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53" name="직선 연결선 52"/>
          <p:cNvCxnSpPr/>
          <p:nvPr/>
        </p:nvCxnSpPr>
        <p:spPr>
          <a:xfrm>
            <a:off x="4973754" y="2466773"/>
            <a:ext cx="104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4804176" y="2481983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116035" y="2481983"/>
            <a:ext cx="38005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329176" y="2481983"/>
            <a:ext cx="442980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4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563171" y="2481983"/>
            <a:ext cx="51781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TM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pic>
        <p:nvPicPr>
          <p:cNvPr id="58" name="그림 57"/>
          <p:cNvPicPr>
            <a:picLocks noChangeAspect="1"/>
          </p:cNvPicPr>
          <p:nvPr/>
        </p:nvPicPr>
        <p:blipFill rotWithShape="1">
          <a:blip r:embed="rId5"/>
          <a:srcRect l="20791" t="60913" r="30521" b="28779"/>
          <a:stretch/>
        </p:blipFill>
        <p:spPr>
          <a:xfrm>
            <a:off x="2828134" y="2680438"/>
            <a:ext cx="3188476" cy="3759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TextBox 59"/>
          <p:cNvSpPr txBox="1"/>
          <p:nvPr/>
        </p:nvSpPr>
        <p:spPr>
          <a:xfrm>
            <a:off x="2334024" y="3150375"/>
            <a:ext cx="533496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Hog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138727" y="2764457"/>
            <a:ext cx="721768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Cpy1-FLAG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206797" y="1835404"/>
            <a:ext cx="397788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Calibri" panose="020F0502020204030204" pitchFamily="34" charset="0"/>
              </a:rPr>
              <a:t>C</a:t>
            </a:r>
            <a:endParaRPr lang="ko-KR" altLang="en-US" sz="1600" b="1" dirty="0">
              <a:latin typeface="Calibri" panose="020F050202020403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994943" y="2521750"/>
            <a:ext cx="879542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Glycosylated form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66" name="직선 연결선 65"/>
          <p:cNvCxnSpPr/>
          <p:nvPr/>
        </p:nvCxnSpPr>
        <p:spPr>
          <a:xfrm>
            <a:off x="6044940" y="2820983"/>
            <a:ext cx="15038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6183616" y="2711661"/>
            <a:ext cx="0" cy="403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5929205" y="2940279"/>
            <a:ext cx="1032685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 smtClean="0">
                <a:latin typeface="Calibri" panose="020F0502020204030204" pitchFamily="34" charset="0"/>
              </a:rPr>
              <a:t>Unglycosylated</a:t>
            </a:r>
            <a:r>
              <a:rPr lang="en-US" altLang="ko-KR" sz="800" dirty="0" smtClean="0">
                <a:latin typeface="Calibri" panose="020F0502020204030204" pitchFamily="34" charset="0"/>
              </a:rPr>
              <a:t> form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grpSp>
        <p:nvGrpSpPr>
          <p:cNvPr id="69" name="그룹 68"/>
          <p:cNvGrpSpPr/>
          <p:nvPr/>
        </p:nvGrpSpPr>
        <p:grpSpPr>
          <a:xfrm>
            <a:off x="6044939" y="2866161"/>
            <a:ext cx="150381" cy="112037"/>
            <a:chOff x="5637114" y="3641758"/>
            <a:chExt cx="144000" cy="108000"/>
          </a:xfrm>
        </p:grpSpPr>
        <p:cxnSp>
          <p:nvCxnSpPr>
            <p:cNvPr id="70" name="직선 연결선 69"/>
            <p:cNvCxnSpPr/>
            <p:nvPr/>
          </p:nvCxnSpPr>
          <p:spPr>
            <a:xfrm>
              <a:off x="5637114" y="3644782"/>
              <a:ext cx="14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/>
            <p:cNvCxnSpPr/>
            <p:nvPr/>
          </p:nvCxnSpPr>
          <p:spPr>
            <a:xfrm>
              <a:off x="5780653" y="3641758"/>
              <a:ext cx="1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6"/>
          <a:srcRect l="26315" t="44006" r="40367" b="13901"/>
          <a:stretch/>
        </p:blipFill>
        <p:spPr>
          <a:xfrm>
            <a:off x="548679" y="2413314"/>
            <a:ext cx="1529691" cy="1347207"/>
          </a:xfrm>
          <a:prstGeom prst="rect">
            <a:avLst/>
          </a:prstGeom>
        </p:spPr>
      </p:pic>
      <p:sp>
        <p:nvSpPr>
          <p:cNvPr id="72" name="TextBox 71"/>
          <p:cNvSpPr txBox="1"/>
          <p:nvPr/>
        </p:nvSpPr>
        <p:spPr>
          <a:xfrm>
            <a:off x="47514" y="1835404"/>
            <a:ext cx="323423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smtClean="0">
                <a:latin typeface="Calibri" pitchFamily="34" charset="0"/>
                <a:cs typeface="Arial" pitchFamily="34" charset="0"/>
              </a:rPr>
              <a:t>A</a:t>
            </a:r>
            <a:endParaRPr lang="ko-KR" altLang="en-US" sz="1600" b="1" dirty="0">
              <a:latin typeface="Calibri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852306" y="3169414"/>
            <a:ext cx="54340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ACT1</a:t>
            </a:r>
            <a:endParaRPr lang="ko-KR" altLang="en-US" sz="800" i="1" dirty="0">
              <a:latin typeface="Calibri" panose="020F050202020403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-72125" y="3135716"/>
            <a:ext cx="594277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HXL1</a:t>
            </a:r>
            <a:r>
              <a:rPr lang="en-US" altLang="ko-KR" sz="800" i="1" baseline="30000" dirty="0" smtClean="0">
                <a:latin typeface="Calibri" panose="020F0502020204030204" pitchFamily="34" charset="0"/>
              </a:rPr>
              <a:t>s</a:t>
            </a:r>
            <a:endParaRPr lang="ko-KR" altLang="en-US" sz="800" i="1" dirty="0">
              <a:latin typeface="Calibri" panose="020F050202020403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-106029" y="2970574"/>
            <a:ext cx="629683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HXL1</a:t>
            </a:r>
            <a:r>
              <a:rPr lang="en-US" altLang="ko-KR" sz="800" i="1" baseline="30000" dirty="0" smtClean="0">
                <a:latin typeface="Calibri" panose="020F0502020204030204" pitchFamily="34" charset="0"/>
              </a:rPr>
              <a:t>us</a:t>
            </a:r>
            <a:endParaRPr lang="ko-KR" altLang="en-US" sz="800" i="1" dirty="0">
              <a:latin typeface="Calibri" panose="020F050202020403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831751" y="2211124"/>
            <a:ext cx="38822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030421" y="2211124"/>
            <a:ext cx="26854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700018" y="2211124"/>
            <a:ext cx="278033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750472" y="2229696"/>
            <a:ext cx="135342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425954" y="3150531"/>
            <a:ext cx="11278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425954" y="3226731"/>
            <a:ext cx="11278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1178663" y="2211124"/>
            <a:ext cx="26854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487860" y="2212866"/>
            <a:ext cx="38822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696691" y="2212866"/>
            <a:ext cx="26854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324800" y="2212866"/>
            <a:ext cx="278033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860173" y="2212866"/>
            <a:ext cx="26854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768052" y="1872963"/>
            <a:ext cx="1327513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Incubation time after thymol treatment (h)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868966" y="5466530"/>
            <a:ext cx="1300230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Calibri" panose="020F0502020204030204" pitchFamily="34" charset="0"/>
              </a:rPr>
              <a:t>Incubation time after thymol treatment (h)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3186157" y="5272469"/>
            <a:ext cx="38822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575658" y="5272469"/>
            <a:ext cx="41048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945257" y="5272469"/>
            <a:ext cx="419847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856140" y="5272469"/>
            <a:ext cx="33993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95" name="직선 연결선 94"/>
          <p:cNvCxnSpPr/>
          <p:nvPr/>
        </p:nvCxnSpPr>
        <p:spPr>
          <a:xfrm>
            <a:off x="2839262" y="5485954"/>
            <a:ext cx="13910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4716380" y="5447006"/>
            <a:ext cx="1300230" cy="351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Calibri" panose="020F0502020204030204" pitchFamily="34" charset="0"/>
              </a:rPr>
              <a:t>Incubation time after thymol treatment (h)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046271" y="5252945"/>
            <a:ext cx="38822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.5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5435772" y="5252945"/>
            <a:ext cx="410482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817465" y="5252945"/>
            <a:ext cx="419847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703554" y="5252945"/>
            <a:ext cx="339931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>
                <a:latin typeface="Calibri" panose="020F0502020204030204" pitchFamily="34" charset="0"/>
              </a:rPr>
              <a:t>0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01" name="직선 연결선 100"/>
          <p:cNvCxnSpPr/>
          <p:nvPr/>
        </p:nvCxnSpPr>
        <p:spPr>
          <a:xfrm>
            <a:off x="4686676" y="5466430"/>
            <a:ext cx="13910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/>
          <p:cNvCxnSpPr/>
          <p:nvPr/>
        </p:nvCxnSpPr>
        <p:spPr>
          <a:xfrm>
            <a:off x="6191974" y="2709952"/>
            <a:ext cx="1" cy="11203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7"/>
          <a:srcRect l="8802" t="9617" r="4011" b="39833"/>
          <a:stretch/>
        </p:blipFill>
        <p:spPr>
          <a:xfrm>
            <a:off x="2628834" y="4067944"/>
            <a:ext cx="1584000" cy="1266423"/>
          </a:xfrm>
          <a:prstGeom prst="rect">
            <a:avLst/>
          </a:prstGeom>
        </p:spPr>
      </p:pic>
      <p:grpSp>
        <p:nvGrpSpPr>
          <p:cNvPr id="89" name="그룹 88"/>
          <p:cNvGrpSpPr/>
          <p:nvPr/>
        </p:nvGrpSpPr>
        <p:grpSpPr>
          <a:xfrm>
            <a:off x="1086019" y="4171750"/>
            <a:ext cx="1223436" cy="252000"/>
            <a:chOff x="3155004" y="1964776"/>
            <a:chExt cx="636542" cy="446166"/>
          </a:xfrm>
        </p:grpSpPr>
        <p:grpSp>
          <p:nvGrpSpPr>
            <p:cNvPr id="102" name="그룹 101"/>
            <p:cNvGrpSpPr/>
            <p:nvPr/>
          </p:nvGrpSpPr>
          <p:grpSpPr>
            <a:xfrm>
              <a:off x="3155004" y="1964778"/>
              <a:ext cx="636542" cy="315251"/>
              <a:chOff x="3155004" y="1964778"/>
              <a:chExt cx="636542" cy="315251"/>
            </a:xfrm>
          </p:grpSpPr>
          <p:cxnSp>
            <p:nvCxnSpPr>
              <p:cNvPr id="104" name="직선 연결선 103"/>
              <p:cNvCxnSpPr/>
              <p:nvPr/>
            </p:nvCxnSpPr>
            <p:spPr>
              <a:xfrm>
                <a:off x="3155004" y="1969858"/>
                <a:ext cx="38397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직선 연결선 104"/>
              <p:cNvCxnSpPr/>
              <p:nvPr/>
            </p:nvCxnSpPr>
            <p:spPr>
              <a:xfrm>
                <a:off x="3536572" y="1964778"/>
                <a:ext cx="0" cy="31525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직선 연결선 105"/>
              <p:cNvCxnSpPr/>
              <p:nvPr/>
            </p:nvCxnSpPr>
            <p:spPr>
              <a:xfrm>
                <a:off x="3287546" y="2277233"/>
                <a:ext cx="50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3" name="직선 연결선 102"/>
            <p:cNvCxnSpPr/>
            <p:nvPr/>
          </p:nvCxnSpPr>
          <p:spPr>
            <a:xfrm>
              <a:off x="3157243" y="1964776"/>
              <a:ext cx="0" cy="44616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TextBox 106"/>
          <p:cNvSpPr txBox="1"/>
          <p:nvPr/>
        </p:nvSpPr>
        <p:spPr>
          <a:xfrm>
            <a:off x="1230252" y="3978626"/>
            <a:ext cx="419847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NS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grpSp>
        <p:nvGrpSpPr>
          <p:cNvPr id="108" name="그룹 107"/>
          <p:cNvGrpSpPr/>
          <p:nvPr/>
        </p:nvGrpSpPr>
        <p:grpSpPr>
          <a:xfrm>
            <a:off x="2962661" y="4199668"/>
            <a:ext cx="1223436" cy="252000"/>
            <a:chOff x="3155004" y="1964776"/>
            <a:chExt cx="636542" cy="446166"/>
          </a:xfrm>
        </p:grpSpPr>
        <p:grpSp>
          <p:nvGrpSpPr>
            <p:cNvPr id="109" name="그룹 108"/>
            <p:cNvGrpSpPr/>
            <p:nvPr/>
          </p:nvGrpSpPr>
          <p:grpSpPr>
            <a:xfrm>
              <a:off x="3155004" y="1964778"/>
              <a:ext cx="636542" cy="315251"/>
              <a:chOff x="3155004" y="1964778"/>
              <a:chExt cx="636542" cy="315251"/>
            </a:xfrm>
          </p:grpSpPr>
          <p:cxnSp>
            <p:nvCxnSpPr>
              <p:cNvPr id="111" name="직선 연결선 110"/>
              <p:cNvCxnSpPr/>
              <p:nvPr/>
            </p:nvCxnSpPr>
            <p:spPr>
              <a:xfrm>
                <a:off x="3155004" y="1969858"/>
                <a:ext cx="38397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직선 연결선 111"/>
              <p:cNvCxnSpPr/>
              <p:nvPr/>
            </p:nvCxnSpPr>
            <p:spPr>
              <a:xfrm>
                <a:off x="3536572" y="1964778"/>
                <a:ext cx="0" cy="31525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직선 연결선 112"/>
              <p:cNvCxnSpPr/>
              <p:nvPr/>
            </p:nvCxnSpPr>
            <p:spPr>
              <a:xfrm>
                <a:off x="3287546" y="2277233"/>
                <a:ext cx="50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0" name="직선 연결선 109"/>
            <p:cNvCxnSpPr/>
            <p:nvPr/>
          </p:nvCxnSpPr>
          <p:spPr>
            <a:xfrm>
              <a:off x="3157243" y="1964776"/>
              <a:ext cx="0" cy="44616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TextBox 113"/>
          <p:cNvSpPr txBox="1"/>
          <p:nvPr/>
        </p:nvSpPr>
        <p:spPr>
          <a:xfrm>
            <a:off x="3126643" y="3998549"/>
            <a:ext cx="419847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NS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937997" y="3937979"/>
            <a:ext cx="419847" cy="223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NS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grpSp>
        <p:nvGrpSpPr>
          <p:cNvPr id="116" name="그룹 115"/>
          <p:cNvGrpSpPr/>
          <p:nvPr/>
        </p:nvGrpSpPr>
        <p:grpSpPr>
          <a:xfrm>
            <a:off x="4804176" y="4127529"/>
            <a:ext cx="1223436" cy="252000"/>
            <a:chOff x="3155004" y="1964776"/>
            <a:chExt cx="636542" cy="446166"/>
          </a:xfrm>
        </p:grpSpPr>
        <p:grpSp>
          <p:nvGrpSpPr>
            <p:cNvPr id="117" name="그룹 116"/>
            <p:cNvGrpSpPr/>
            <p:nvPr/>
          </p:nvGrpSpPr>
          <p:grpSpPr>
            <a:xfrm>
              <a:off x="3155004" y="1964778"/>
              <a:ext cx="636542" cy="315251"/>
              <a:chOff x="3155004" y="1964778"/>
              <a:chExt cx="636542" cy="315251"/>
            </a:xfrm>
          </p:grpSpPr>
          <p:cxnSp>
            <p:nvCxnSpPr>
              <p:cNvPr id="119" name="직선 연결선 118"/>
              <p:cNvCxnSpPr/>
              <p:nvPr/>
            </p:nvCxnSpPr>
            <p:spPr>
              <a:xfrm>
                <a:off x="3155004" y="1969858"/>
                <a:ext cx="38397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직선 연결선 119"/>
              <p:cNvCxnSpPr/>
              <p:nvPr/>
            </p:nvCxnSpPr>
            <p:spPr>
              <a:xfrm>
                <a:off x="3536572" y="1964778"/>
                <a:ext cx="0" cy="31525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직선 연결선 120"/>
              <p:cNvCxnSpPr/>
              <p:nvPr/>
            </p:nvCxnSpPr>
            <p:spPr>
              <a:xfrm>
                <a:off x="3287546" y="2277233"/>
                <a:ext cx="50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8" name="직선 연결선 117"/>
            <p:cNvCxnSpPr/>
            <p:nvPr/>
          </p:nvCxnSpPr>
          <p:spPr>
            <a:xfrm>
              <a:off x="3157243" y="1964776"/>
              <a:ext cx="0" cy="44616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22" name="그림 121"/>
          <p:cNvPicPr preferRelativeResize="0">
            <a:picLocks/>
          </p:cNvPicPr>
          <p:nvPr/>
        </p:nvPicPr>
        <p:blipFill rotWithShape="1">
          <a:blip r:embed="rId8"/>
          <a:srcRect l="32768" t="58590" r="20629" b="35934"/>
          <a:stretch/>
        </p:blipFill>
        <p:spPr>
          <a:xfrm>
            <a:off x="2828133" y="3101960"/>
            <a:ext cx="3188477" cy="3744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462352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18</TotalTime>
  <Words>284</Words>
  <Application>Microsoft Office PowerPoint</Application>
  <PresentationFormat>화면 슬라이드 쇼(4:3)</PresentationFormat>
  <Paragraphs>5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90</cp:revision>
  <cp:lastPrinted>2016-04-27T13:11:43Z</cp:lastPrinted>
  <dcterms:created xsi:type="dcterms:W3CDTF">2015-09-22T05:34:13Z</dcterms:created>
  <dcterms:modified xsi:type="dcterms:W3CDTF">2021-05-25T10:45:26Z</dcterms:modified>
</cp:coreProperties>
</file>